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3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27" autoAdjust="0"/>
    <p:restoredTop sz="94660"/>
  </p:normalViewPr>
  <p:slideViewPr>
    <p:cSldViewPr snapToGrid="0">
      <p:cViewPr varScale="1">
        <p:scale>
          <a:sx n="44" d="100"/>
          <a:sy n="44" d="100"/>
        </p:scale>
        <p:origin x="42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D78D99-55B6-12E3-28F5-F8C96927E1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F50A745-BA25-B260-655B-8FE49FABD6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D3FA7E-C57C-4F55-CD4C-A7355E454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D39A79-BBCB-8FF5-4C75-221135F26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D8B6A1-B05A-DA81-FEAE-12B57F5A1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0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A46661-C1E7-3411-D2A6-BD271EEF3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1515308-FA9F-538D-98C7-8D94824AB2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8B054F5-9C9B-941E-0134-C8A355CFC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2B04D4-108E-E7BF-5F31-F43B2189E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0941C2-B1FB-5AB8-8448-087C8A5A0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0473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9020934-0B5C-C387-C6D2-86AB880B0C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E2BAE6D-3C42-DA95-016A-446821C9AB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93CB19-965A-3A04-3235-A699EB122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329C57-9325-2315-4E55-975A221B8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E487C8-86A4-6986-EF45-DA13D8076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752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2AE3DA-2601-82B0-13ED-5AB872085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47C9F15-0923-C651-13C8-1FCCFE6426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A6D412-CB74-12D0-AC78-8D8C9551D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AA4144-0666-EA6A-9C77-AC3DC4027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3EC5F8-A2AD-9AB1-D7D5-97D37713C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3913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775C07-A3E1-A962-3EA2-4E5B98EB3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F9DBDD-6E6B-E2F6-F2E5-8CC39E8962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774DA2-22B6-1103-A884-F0B669B5E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E35CF2-8A42-DE4B-1B7F-AA23A1898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588085-DC46-1DF7-7877-379A7292D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4046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69908D-A164-A731-D7C6-0567F400BD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100368-7CD1-972B-CE75-3758001591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3DE380C-E0AB-1E3C-2B94-969AE17030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AF450E-CF20-588E-0DEA-B5591EC6D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778E639-5158-570F-6692-074E6D089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46D73D-056F-CEBC-B40D-7D38FE792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512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253BE0-7AB8-36D4-876A-E96A9F60EB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6B625C-F3C9-34AD-7EBA-AA28D1834A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11428A2-7745-C3FF-7D17-B885175148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50F8A62-C3DE-2DFA-4251-ED484DD95D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FD62824-0FD1-3046-E269-2408A458FE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31D55E5-7967-E1FB-FF39-A46EC07D3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6805D1B-8DB6-4476-89D4-30D422B3F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EBA8AD7-1B5C-908E-6F22-8B58E2AA3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227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CCCC6D-CAD0-7133-72F0-A6583E95C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1D3B781-D8BD-0E2C-F55C-A50A2F897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DAC95C2-0B02-2BAC-A26A-4303C4564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9FF5337-7FD1-777D-EE61-02B5D5B13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8689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AD61495-CB05-DF91-E8F0-54A2A7678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98CF2A3-1B9E-3B6C-BF92-AFD626A06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01FA406-C87F-0D92-CCBE-E30F193F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223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949F24-DF4F-0CEB-6098-D32EDD2109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C56F343-26A5-C8B4-1FB7-DC6498D4C5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027BD49-5791-F5D4-C569-F507A8BBA0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C22D756-F794-C7E5-3DDA-0E07D9912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6C7867-860D-97D0-5482-548C71C079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D6BCF1-9967-D5CB-642C-B1090C04D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190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655470-15DD-9CB7-C56E-42FFEBC79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9256813-CDEB-01AC-621C-20F9AB61A7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8266C04-06BE-54A3-328B-48081BC9BD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16A4D3-DD01-0306-0649-F39CAA6B0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D00D5E7-B0B1-A938-7C66-B89568601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0BAB06-E5EE-F615-93C0-577110A21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548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5FFD1A2-A4C9-CA62-4FE2-9DB5ED1D8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1CE79B-988D-3ED2-7EFE-F0DDB1259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F86D1D-4095-6A1B-D180-1AEF31C555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E7B8B6-0A9F-4ADF-A4BD-1B8C82E00CCC}" type="datetimeFigureOut">
              <a:rPr kumimoji="1" lang="ja-JP" altLang="en-US" smtClean="0"/>
              <a:t>2025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248F68-6AC9-119A-D177-DC16FE246A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6D14DA-F14A-5E1B-1FF8-6232564472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2F7ACF-D54A-4210-BC72-DBDB82B4A5D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100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754FEF93-1A3E-D336-7833-A887C107C62A}"/>
              </a:ext>
            </a:extLst>
          </p:cNvPr>
          <p:cNvGrpSpPr/>
          <p:nvPr/>
        </p:nvGrpSpPr>
        <p:grpSpPr>
          <a:xfrm>
            <a:off x="945711" y="1386520"/>
            <a:ext cx="5040000" cy="3600000"/>
            <a:chOff x="800100" y="4368800"/>
            <a:chExt cx="2413000" cy="1724294"/>
          </a:xfrm>
        </p:grpSpPr>
        <p:pic>
          <p:nvPicPr>
            <p:cNvPr id="16" name="Picture 9">
              <a:extLst>
                <a:ext uri="{FF2B5EF4-FFF2-40B4-BE49-F238E27FC236}">
                  <a16:creationId xmlns:a16="http://schemas.microsoft.com/office/drawing/2014/main" id="{E5DF767B-6556-600F-E414-27E1FA5675B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10" t="5344" r="24874"/>
            <a:stretch/>
          </p:blipFill>
          <p:spPr bwMode="auto">
            <a:xfrm>
              <a:off x="800100" y="4368800"/>
              <a:ext cx="2413000" cy="1724294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77279352-AB0A-4A9C-4B5C-80F29E9BCA3E}"/>
                </a:ext>
              </a:extLst>
            </p:cNvPr>
            <p:cNvCxnSpPr/>
            <p:nvPr/>
          </p:nvCxnSpPr>
          <p:spPr>
            <a:xfrm>
              <a:off x="2034673" y="4471547"/>
              <a:ext cx="0" cy="436076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tailEnd type="arrow"/>
            </a:ln>
            <a:effectLst/>
          </p:spPr>
        </p:cxn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8AE5E89-D83F-FA8E-1251-6D47DBEC4052}"/>
              </a:ext>
            </a:extLst>
          </p:cNvPr>
          <p:cNvSpPr txBox="1"/>
          <p:nvPr/>
        </p:nvSpPr>
        <p:spPr>
          <a:xfrm>
            <a:off x="945710" y="5201036"/>
            <a:ext cx="50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A    T   G     T   A   T    G    A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G</a:t>
            </a:r>
            <a:endParaRPr lang="ja-JP" altLang="en-US" sz="1200" b="1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A30BEFD-C725-2030-D8EA-727F37F1A1AF}"/>
              </a:ext>
            </a:extLst>
          </p:cNvPr>
          <p:cNvSpPr txBox="1"/>
          <p:nvPr/>
        </p:nvSpPr>
        <p:spPr>
          <a:xfrm>
            <a:off x="3408794" y="554246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endParaRPr lang="ja-JP" altLang="en-US" sz="1200" b="1" dirty="0">
              <a:solidFill>
                <a:srgbClr val="FF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9E2ACBF-688C-C75A-7AB4-343AB85F1AF1}"/>
              </a:ext>
            </a:extLst>
          </p:cNvPr>
          <p:cNvSpPr txBox="1"/>
          <p:nvPr/>
        </p:nvSpPr>
        <p:spPr>
          <a:xfrm>
            <a:off x="945711" y="1031691"/>
            <a:ext cx="26740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IT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exon 11 mutation (T&gt;C)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21" name="Picture 10">
            <a:extLst>
              <a:ext uri="{FF2B5EF4-FFF2-40B4-BE49-F238E27FC236}">
                <a16:creationId xmlns:a16="http://schemas.microsoft.com/office/drawing/2014/main" id="{85669089-BD0C-11C8-E5F6-E9CB7FDDAA4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7" t="2604" r="23112" b="-409"/>
          <a:stretch/>
        </p:blipFill>
        <p:spPr bwMode="auto">
          <a:xfrm>
            <a:off x="6380111" y="1392311"/>
            <a:ext cx="5040148" cy="3600000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7B9DE93-CE14-D2FE-1136-9C4798C32C05}"/>
              </a:ext>
            </a:extLst>
          </p:cNvPr>
          <p:cNvSpPr txBox="1"/>
          <p:nvPr/>
        </p:nvSpPr>
        <p:spPr>
          <a:xfrm>
            <a:off x="6380111" y="5201035"/>
            <a:ext cx="5040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    G    A   G   T 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A  C 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 T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</a:t>
            </a: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 G    </a:t>
            </a:r>
            <a:r>
              <a:rPr lang="en-US" altLang="ja-JP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G</a:t>
            </a:r>
            <a:endParaRPr lang="ja-JP" altLang="en-US" sz="1200" b="1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1322E41-E901-D30F-6D8A-656E77EB17EA}"/>
              </a:ext>
            </a:extLst>
          </p:cNvPr>
          <p:cNvSpPr txBox="1"/>
          <p:nvPr/>
        </p:nvSpPr>
        <p:spPr>
          <a:xfrm>
            <a:off x="8778248" y="5542461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G</a:t>
            </a:r>
            <a:endParaRPr lang="ja-JP" altLang="en-US" sz="1200" b="1" dirty="0">
              <a:solidFill>
                <a:srgbClr val="FF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35DA8F4-952E-93A4-130F-D27EE13738FC}"/>
              </a:ext>
            </a:extLst>
          </p:cNvPr>
          <p:cNvSpPr txBox="1"/>
          <p:nvPr/>
        </p:nvSpPr>
        <p:spPr>
          <a:xfrm>
            <a:off x="6380111" y="1036920"/>
            <a:ext cx="27093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IT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exon 13 mutation (A&gt;G)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0ADF0DDF-6DF1-168C-2677-59BA5680A009}"/>
              </a:ext>
            </a:extLst>
          </p:cNvPr>
          <p:cNvCxnSpPr/>
          <p:nvPr/>
        </p:nvCxnSpPr>
        <p:spPr>
          <a:xfrm>
            <a:off x="8900185" y="1601036"/>
            <a:ext cx="0" cy="503427"/>
          </a:xfrm>
          <a:prstGeom prst="straightConnector1">
            <a:avLst/>
          </a:prstGeom>
          <a:noFill/>
          <a:ln w="38100" cap="flat" cmpd="sng" algn="ctr">
            <a:solidFill>
              <a:sysClr val="windowText" lastClr="000000"/>
            </a:solidFill>
            <a:prstDash val="solid"/>
            <a:tailEnd type="arrow"/>
          </a:ln>
          <a:effectLst/>
        </p:spPr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BE5EC95-3C05-69A6-930D-E476508B78B1}"/>
              </a:ext>
            </a:extLst>
          </p:cNvPr>
          <p:cNvSpPr txBox="1"/>
          <p:nvPr/>
        </p:nvSpPr>
        <p:spPr>
          <a:xfrm>
            <a:off x="4107845" y="6230851"/>
            <a:ext cx="42242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Sanger sequencing results in Case 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5778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oro Takahashi</dc:creator>
  <cp:lastModifiedBy>Goro Takahashi</cp:lastModifiedBy>
  <cp:revision>1</cp:revision>
  <dcterms:created xsi:type="dcterms:W3CDTF">2025-02-21T01:41:03Z</dcterms:created>
  <dcterms:modified xsi:type="dcterms:W3CDTF">2025-02-21T01:41:28Z</dcterms:modified>
</cp:coreProperties>
</file>